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0" d="100"/>
          <a:sy n="60" d="100"/>
        </p:scale>
        <p:origin x="-3714" y="-10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us\Desktop\DP%20FOLDER\ZZZ%20-%20211M%20Paper\02%20-%20Figures%20for%20211%20PAPER\SUPP.%20FIGURE%2004\SUPP.%20FIGURE%2004%20-%20MITF%20siRNA%20-%20v0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us\Desktop\DP%20FOLDER\ZZZ%20-%20211M%20Paper\02%20-%20Figures%20for%20211%20PAPER\SUPP.%20FIGURE%2004\SUPP.%20FIGURE%2004%20-%20MITF%20siRNA%20-%20v01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us\Desktop\DP%20FOLDER\ZZZ%20-%20211M%20Paper\02%20-%20Figures%20for%20211%20PAPER\SUPP.%20FIGURE%2004\SUPP.%20FIGURE%2004%20-%20MITF%20siRNA%20-%20v01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us\Desktop\DP%20FOLDER\ZZZ%20-%20211M%20Paper\02%20-%20Figures%20for%20211%20PAPER\SUPP.%20FIGURE%2004\SUPP.%20FIGURE%2004%20-%20MITF%20siRNA%20-%20v01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us\Desktop\DP%20FOLDER\ZZZ%20-%20211M%20Paper\02%20-%20Figures%20for%20211%20PAPER\SUPP.%20FIGURE%2004\SUPP.%20FIGURE%2004%20-%20MITF%20siRNA%20-%20v0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1"/>
          <c:tx>
            <c:v>M6PR</c:v>
          </c:tx>
          <c:spPr>
            <a:solidFill>
              <a:schemeClr val="accent1">
                <a:lumMod val="60000"/>
                <a:lumOff val="4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For GraphPad FM55M1(Dupls)'!$K$64;'For GraphPad FM55M1(Dupls)'!$M$64;'For GraphPad FM55M1(Dupls)'!$O$64)</c:f>
                <c:numCache>
                  <c:formatCode>General</c:formatCode>
                  <c:ptCount val="3"/>
                  <c:pt idx="0">
                    <c:v>7.2366634380831643E-2</c:v>
                  </c:pt>
                  <c:pt idx="1">
                    <c:v>0.1070484698407351</c:v>
                  </c:pt>
                  <c:pt idx="2">
                    <c:v>0.12716231913980788</c:v>
                  </c:pt>
                </c:numCache>
              </c:numRef>
            </c:plus>
            <c:minus>
              <c:numRef>
                <c:f>('For GraphPad FM55M1(Dupls)'!$K$64;'For GraphPad FM55M1(Dupls)'!$M$64;'For GraphPad FM55M1(Dupls)'!$O$64)</c:f>
                <c:numCache>
                  <c:formatCode>General</c:formatCode>
                  <c:ptCount val="3"/>
                  <c:pt idx="0">
                    <c:v>7.2366634380831643E-2</c:v>
                  </c:pt>
                  <c:pt idx="1">
                    <c:v>0.1070484698407351</c:v>
                  </c:pt>
                  <c:pt idx="2">
                    <c:v>0.12716231913980788</c:v>
                  </c:pt>
                </c:numCache>
              </c:numRef>
            </c:minus>
          </c:errBars>
          <c:cat>
            <c:strRef>
              <c:f>'For GraphPad FM55M1(Dupls)'!$Q$1:$Q$3</c:f>
              <c:strCache>
                <c:ptCount val="3"/>
                <c:pt idx="0">
                  <c:v>24h</c:v>
                </c:pt>
                <c:pt idx="1">
                  <c:v>48h</c:v>
                </c:pt>
                <c:pt idx="2">
                  <c:v>72h</c:v>
                </c:pt>
              </c:strCache>
            </c:strRef>
          </c:cat>
          <c:val>
            <c:numRef>
              <c:f>('For GraphPad FM55M1(Dupls)'!$K$62;'For GraphPad FM55M1(Dupls)'!$M$62;'For GraphPad FM55M1(Dupls)'!$O$62)</c:f>
              <c:numCache>
                <c:formatCode>0.00</c:formatCode>
                <c:ptCount val="3"/>
                <c:pt idx="0">
                  <c:v>0.70880455316801083</c:v>
                </c:pt>
                <c:pt idx="1">
                  <c:v>0.68992395289983999</c:v>
                </c:pt>
                <c:pt idx="2">
                  <c:v>0.734994618512974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0050944"/>
        <c:axId val="31326208"/>
      </c:barChart>
      <c:lineChart>
        <c:grouping val="standard"/>
        <c:varyColors val="0"/>
        <c:ser>
          <c:idx val="1"/>
          <c:order val="0"/>
          <c:tx>
            <c:v>miR211</c:v>
          </c:tx>
          <c:spPr>
            <a:ln>
              <a:solidFill>
                <a:schemeClr val="tx1">
                  <a:lumMod val="65000"/>
                  <a:lumOff val="35000"/>
                </a:schemeClr>
              </a:solidFill>
            </a:ln>
          </c:spPr>
          <c:marker>
            <c:spPr>
              <a:solidFill>
                <a:schemeClr val="tx1">
                  <a:lumMod val="65000"/>
                  <a:lumOff val="35000"/>
                </a:schemeClr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For GraphPad FM55M1(Dupls)'!$K$12;'For GraphPad FM55M1(Dupls)'!$M$12;'For GraphPad FM55M1(Dupls)'!$O$12)</c:f>
                <c:numCache>
                  <c:formatCode>General</c:formatCode>
                  <c:ptCount val="3"/>
                  <c:pt idx="0">
                    <c:v>0.21239829593429507</c:v>
                  </c:pt>
                  <c:pt idx="1">
                    <c:v>0.19924439680856673</c:v>
                  </c:pt>
                  <c:pt idx="2">
                    <c:v>0.11827090535547422</c:v>
                  </c:pt>
                </c:numCache>
              </c:numRef>
            </c:plus>
            <c:minus>
              <c:numRef>
                <c:f>('For GraphPad FM55M1(Dupls)'!$K$12;'For GraphPad FM55M1(Dupls)'!$M$12;'For GraphPad FM55M1(Dupls)'!$O$12)</c:f>
                <c:numCache>
                  <c:formatCode>General</c:formatCode>
                  <c:ptCount val="3"/>
                  <c:pt idx="0">
                    <c:v>0.21239829593429507</c:v>
                  </c:pt>
                  <c:pt idx="1">
                    <c:v>0.19924439680856673</c:v>
                  </c:pt>
                  <c:pt idx="2">
                    <c:v>0.11827090535547422</c:v>
                  </c:pt>
                </c:numCache>
              </c:numRef>
            </c:minus>
          </c:errBars>
          <c:cat>
            <c:strRef>
              <c:f>'For GraphPad FM55M1(Dupls)'!$Q$1:$Q$3</c:f>
              <c:strCache>
                <c:ptCount val="3"/>
                <c:pt idx="0">
                  <c:v>24h</c:v>
                </c:pt>
                <c:pt idx="1">
                  <c:v>48h</c:v>
                </c:pt>
                <c:pt idx="2">
                  <c:v>72h</c:v>
                </c:pt>
              </c:strCache>
            </c:strRef>
          </c:cat>
          <c:val>
            <c:numRef>
              <c:f>('For GraphPad FM55M1(Dupls)'!$K$10;'For GraphPad FM55M1(Dupls)'!$M$10;'For GraphPad FM55M1(Dupls)'!$O$10)</c:f>
              <c:numCache>
                <c:formatCode>0.00</c:formatCode>
                <c:ptCount val="3"/>
                <c:pt idx="0">
                  <c:v>0.94597556453400722</c:v>
                </c:pt>
                <c:pt idx="1">
                  <c:v>0.69611823005674733</c:v>
                </c:pt>
                <c:pt idx="2">
                  <c:v>0.4691613698847438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0050944"/>
        <c:axId val="31326208"/>
      </c:lineChart>
      <c:catAx>
        <c:axId val="3005094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31326208"/>
        <c:crosses val="autoZero"/>
        <c:auto val="1"/>
        <c:lblAlgn val="ctr"/>
        <c:lblOffset val="100"/>
        <c:noMultiLvlLbl val="0"/>
      </c:catAx>
      <c:valAx>
        <c:axId val="31326208"/>
        <c:scaling>
          <c:orientation val="minMax"/>
          <c:max val="1.4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/>
                </a:pPr>
                <a:r>
                  <a:rPr lang="en-US" sz="700"/>
                  <a:t>Relative Expression</a:t>
                </a:r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30050944"/>
        <c:crosses val="autoZero"/>
        <c:crossBetween val="between"/>
        <c:majorUnit val="0.2"/>
      </c:valAx>
    </c:plotArea>
    <c:legend>
      <c:legendPos val="t"/>
      <c:layout>
        <c:manualLayout>
          <c:xMode val="edge"/>
          <c:yMode val="edge"/>
          <c:x val="0.27651342298341147"/>
          <c:y val="0"/>
          <c:w val="0.49685422815573382"/>
          <c:h val="0.10041283902012248"/>
        </c:manualLayout>
      </c:layout>
      <c:overlay val="1"/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1"/>
          <c:tx>
            <c:v>SSRP1</c:v>
          </c:tx>
          <c:spPr>
            <a:solidFill>
              <a:schemeClr val="accent1">
                <a:lumMod val="60000"/>
                <a:lumOff val="4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For GraphPad FM55M1(Dupls)'!$K$75;'For GraphPad FM55M1(Dupls)'!$M$75;'For GraphPad FM55M1(Dupls)'!$O$75)</c:f>
                <c:numCache>
                  <c:formatCode>General</c:formatCode>
                  <c:ptCount val="3"/>
                  <c:pt idx="0">
                    <c:v>0.11140448372737508</c:v>
                  </c:pt>
                  <c:pt idx="1">
                    <c:v>9.6810118239029824E-2</c:v>
                  </c:pt>
                  <c:pt idx="2">
                    <c:v>6.1757153018555097E-2</c:v>
                  </c:pt>
                </c:numCache>
              </c:numRef>
            </c:plus>
            <c:minus>
              <c:numRef>
                <c:f>('For GraphPad FM55M1(Dupls)'!$K$75;'For GraphPad FM55M1(Dupls)'!$M$75;'For GraphPad FM55M1(Dupls)'!$O$75)</c:f>
                <c:numCache>
                  <c:formatCode>General</c:formatCode>
                  <c:ptCount val="3"/>
                  <c:pt idx="0">
                    <c:v>0.11140448372737508</c:v>
                  </c:pt>
                  <c:pt idx="1">
                    <c:v>9.6810118239029824E-2</c:v>
                  </c:pt>
                  <c:pt idx="2">
                    <c:v>6.1757153018555097E-2</c:v>
                  </c:pt>
                </c:numCache>
              </c:numRef>
            </c:minus>
          </c:errBars>
          <c:cat>
            <c:strRef>
              <c:f>'For GraphPad FM55M1(Dupls)'!$Q$1:$Q$3</c:f>
              <c:strCache>
                <c:ptCount val="3"/>
                <c:pt idx="0">
                  <c:v>24h</c:v>
                </c:pt>
                <c:pt idx="1">
                  <c:v>48h</c:v>
                </c:pt>
                <c:pt idx="2">
                  <c:v>72h</c:v>
                </c:pt>
              </c:strCache>
            </c:strRef>
          </c:cat>
          <c:val>
            <c:numRef>
              <c:f>('For GraphPad FM55M1(Dupls)'!$K$73;'For GraphPad FM55M1(Dupls)'!$M$73;'For GraphPad FM55M1(Dupls)'!$O$73)</c:f>
              <c:numCache>
                <c:formatCode>0.00</c:formatCode>
                <c:ptCount val="3"/>
                <c:pt idx="0">
                  <c:v>1.0379143043033039</c:v>
                </c:pt>
                <c:pt idx="1">
                  <c:v>0.88919003157108123</c:v>
                </c:pt>
                <c:pt idx="2">
                  <c:v>0.8045647302702125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4692864"/>
        <c:axId val="93360128"/>
      </c:barChart>
      <c:lineChart>
        <c:grouping val="standard"/>
        <c:varyColors val="0"/>
        <c:ser>
          <c:idx val="1"/>
          <c:order val="0"/>
          <c:tx>
            <c:v>miR211</c:v>
          </c:tx>
          <c:spPr>
            <a:ln>
              <a:solidFill>
                <a:schemeClr val="tx1">
                  <a:lumMod val="65000"/>
                  <a:lumOff val="35000"/>
                </a:schemeClr>
              </a:solidFill>
            </a:ln>
          </c:spPr>
          <c:marker>
            <c:spPr>
              <a:solidFill>
                <a:schemeClr val="tx1">
                  <a:lumMod val="65000"/>
                  <a:lumOff val="35000"/>
                </a:schemeClr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For GraphPad FM55M1(Dupls)'!$K$12;'For GraphPad FM55M1(Dupls)'!$M$12;'For GraphPad FM55M1(Dupls)'!$O$12)</c:f>
                <c:numCache>
                  <c:formatCode>General</c:formatCode>
                  <c:ptCount val="3"/>
                  <c:pt idx="0">
                    <c:v>0.21239829593429507</c:v>
                  </c:pt>
                  <c:pt idx="1">
                    <c:v>0.19924439680856648</c:v>
                  </c:pt>
                  <c:pt idx="2">
                    <c:v>0.11827090535547406</c:v>
                  </c:pt>
                </c:numCache>
              </c:numRef>
            </c:plus>
            <c:minus>
              <c:numRef>
                <c:f>('For GraphPad FM55M1(Dupls)'!$K$12;'For GraphPad FM55M1(Dupls)'!$M$12;'For GraphPad FM55M1(Dupls)'!$O$12)</c:f>
                <c:numCache>
                  <c:formatCode>General</c:formatCode>
                  <c:ptCount val="3"/>
                  <c:pt idx="0">
                    <c:v>0.21239829593429507</c:v>
                  </c:pt>
                  <c:pt idx="1">
                    <c:v>0.19924439680856648</c:v>
                  </c:pt>
                  <c:pt idx="2">
                    <c:v>0.11827090535547406</c:v>
                  </c:pt>
                </c:numCache>
              </c:numRef>
            </c:minus>
          </c:errBars>
          <c:cat>
            <c:strRef>
              <c:f>'For GraphPad FM55M1(Dupls)'!$Q$1:$Q$3</c:f>
              <c:strCache>
                <c:ptCount val="3"/>
                <c:pt idx="0">
                  <c:v>24h</c:v>
                </c:pt>
                <c:pt idx="1">
                  <c:v>48h</c:v>
                </c:pt>
                <c:pt idx="2">
                  <c:v>72h</c:v>
                </c:pt>
              </c:strCache>
            </c:strRef>
          </c:cat>
          <c:val>
            <c:numRef>
              <c:f>('For GraphPad FM55M1(Dupls)'!$K$10;'For GraphPad FM55M1(Dupls)'!$M$10;'For GraphPad FM55M1(Dupls)'!$O$10)</c:f>
              <c:numCache>
                <c:formatCode>0.00</c:formatCode>
                <c:ptCount val="3"/>
                <c:pt idx="0">
                  <c:v>0.94597556453400722</c:v>
                </c:pt>
                <c:pt idx="1">
                  <c:v>0.69611823005674622</c:v>
                </c:pt>
                <c:pt idx="2">
                  <c:v>0.4691613698847438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4692864"/>
        <c:axId val="93360128"/>
      </c:lineChart>
      <c:catAx>
        <c:axId val="7469286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93360128"/>
        <c:crosses val="autoZero"/>
        <c:auto val="1"/>
        <c:lblAlgn val="ctr"/>
        <c:lblOffset val="100"/>
        <c:noMultiLvlLbl val="0"/>
      </c:catAx>
      <c:valAx>
        <c:axId val="93360128"/>
        <c:scaling>
          <c:orientation val="minMax"/>
          <c:max val="1.4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/>
                </a:pPr>
                <a:r>
                  <a:rPr lang="en-US" sz="700"/>
                  <a:t>Relative Expression</a:t>
                </a:r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74692864"/>
        <c:crosses val="autoZero"/>
        <c:crossBetween val="between"/>
        <c:majorUnit val="0.2"/>
      </c:valAx>
    </c:plotArea>
    <c:legend>
      <c:legendPos val="t"/>
      <c:layout>
        <c:manualLayout>
          <c:xMode val="edge"/>
          <c:yMode val="edge"/>
          <c:x val="0.28099557396413782"/>
          <c:y val="0"/>
          <c:w val="0.49685422815573382"/>
          <c:h val="0.10041283902012248"/>
        </c:manualLayout>
      </c:layout>
      <c:overlay val="1"/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1"/>
          <c:tx>
            <c:v>AP1S2</c:v>
          </c:tx>
          <c:spPr>
            <a:solidFill>
              <a:schemeClr val="accent1">
                <a:lumMod val="60000"/>
                <a:lumOff val="4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For GraphPad FM55M1(Dupls)'!$K$51;'For GraphPad FM55M1(Dupls)'!$M$51;'For GraphPad FM55M1(Dupls)'!$O$51)</c:f>
                <c:numCache>
                  <c:formatCode>General</c:formatCode>
                  <c:ptCount val="3"/>
                  <c:pt idx="0">
                    <c:v>4.5167903772686507E-2</c:v>
                  </c:pt>
                  <c:pt idx="1">
                    <c:v>9.7796212085558054E-2</c:v>
                  </c:pt>
                  <c:pt idx="2">
                    <c:v>5.9934067996172992E-2</c:v>
                  </c:pt>
                </c:numCache>
              </c:numRef>
            </c:plus>
            <c:minus>
              <c:numRef>
                <c:f>('For GraphPad FM55M1(Dupls)'!$K$51;'For GraphPad FM55M1(Dupls)'!$M$51;'For GraphPad FM55M1(Dupls)'!$O$51)</c:f>
                <c:numCache>
                  <c:formatCode>General</c:formatCode>
                  <c:ptCount val="3"/>
                  <c:pt idx="0">
                    <c:v>4.5167903772686507E-2</c:v>
                  </c:pt>
                  <c:pt idx="1">
                    <c:v>9.7796212085558054E-2</c:v>
                  </c:pt>
                  <c:pt idx="2">
                    <c:v>5.9934067996172992E-2</c:v>
                  </c:pt>
                </c:numCache>
              </c:numRef>
            </c:minus>
          </c:errBars>
          <c:cat>
            <c:strRef>
              <c:f>'For GraphPad FM55M1(Dupls)'!$Q$1:$Q$3</c:f>
              <c:strCache>
                <c:ptCount val="3"/>
                <c:pt idx="0">
                  <c:v>24h</c:v>
                </c:pt>
                <c:pt idx="1">
                  <c:v>48h</c:v>
                </c:pt>
                <c:pt idx="2">
                  <c:v>72h</c:v>
                </c:pt>
              </c:strCache>
            </c:strRef>
          </c:cat>
          <c:val>
            <c:numRef>
              <c:f>('For GraphPad FM55M1(Dupls)'!$K$49;'For GraphPad FM55M1(Dupls)'!$M$49;'For GraphPad FM55M1(Dupls)'!$O$49)</c:f>
              <c:numCache>
                <c:formatCode>0.00</c:formatCode>
                <c:ptCount val="3"/>
                <c:pt idx="0">
                  <c:v>0.80177514406648365</c:v>
                </c:pt>
                <c:pt idx="1">
                  <c:v>1.0094150085787641</c:v>
                </c:pt>
                <c:pt idx="2">
                  <c:v>0.8443210284848556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9584256"/>
        <c:axId val="99761536"/>
      </c:barChart>
      <c:lineChart>
        <c:grouping val="standard"/>
        <c:varyColors val="0"/>
        <c:ser>
          <c:idx val="1"/>
          <c:order val="0"/>
          <c:tx>
            <c:v>miR211</c:v>
          </c:tx>
          <c:spPr>
            <a:ln>
              <a:solidFill>
                <a:schemeClr val="tx1">
                  <a:lumMod val="65000"/>
                  <a:lumOff val="35000"/>
                </a:schemeClr>
              </a:solidFill>
            </a:ln>
          </c:spPr>
          <c:marker>
            <c:spPr>
              <a:solidFill>
                <a:schemeClr val="tx1">
                  <a:lumMod val="65000"/>
                  <a:lumOff val="35000"/>
                </a:schemeClr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For GraphPad FM55M1(Dupls)'!$K$12;'For GraphPad FM55M1(Dupls)'!$M$12;'For GraphPad FM55M1(Dupls)'!$O$12)</c:f>
                <c:numCache>
                  <c:formatCode>General</c:formatCode>
                  <c:ptCount val="3"/>
                  <c:pt idx="0">
                    <c:v>0.21239829593429507</c:v>
                  </c:pt>
                  <c:pt idx="1">
                    <c:v>0.19924439680856648</c:v>
                  </c:pt>
                  <c:pt idx="2">
                    <c:v>0.11827090535547406</c:v>
                  </c:pt>
                </c:numCache>
              </c:numRef>
            </c:plus>
            <c:minus>
              <c:numRef>
                <c:f>('For GraphPad FM55M1(Dupls)'!$K$12;'For GraphPad FM55M1(Dupls)'!$M$12;'For GraphPad FM55M1(Dupls)'!$O$12)</c:f>
                <c:numCache>
                  <c:formatCode>General</c:formatCode>
                  <c:ptCount val="3"/>
                  <c:pt idx="0">
                    <c:v>0.21239829593429507</c:v>
                  </c:pt>
                  <c:pt idx="1">
                    <c:v>0.19924439680856648</c:v>
                  </c:pt>
                  <c:pt idx="2">
                    <c:v>0.11827090535547406</c:v>
                  </c:pt>
                </c:numCache>
              </c:numRef>
            </c:minus>
          </c:errBars>
          <c:cat>
            <c:strRef>
              <c:f>'For GraphPad FM55M1(Dupls)'!$Q$1:$Q$3</c:f>
              <c:strCache>
                <c:ptCount val="3"/>
                <c:pt idx="0">
                  <c:v>24h</c:v>
                </c:pt>
                <c:pt idx="1">
                  <c:v>48h</c:v>
                </c:pt>
                <c:pt idx="2">
                  <c:v>72h</c:v>
                </c:pt>
              </c:strCache>
            </c:strRef>
          </c:cat>
          <c:val>
            <c:numRef>
              <c:f>('For GraphPad FM55M1(Dupls)'!$K$10;'For GraphPad FM55M1(Dupls)'!$M$10;'For GraphPad FM55M1(Dupls)'!$O$10)</c:f>
              <c:numCache>
                <c:formatCode>0.00</c:formatCode>
                <c:ptCount val="3"/>
                <c:pt idx="0">
                  <c:v>0.94597556453400722</c:v>
                </c:pt>
                <c:pt idx="1">
                  <c:v>0.69611823005674622</c:v>
                </c:pt>
                <c:pt idx="2">
                  <c:v>0.4691613698847438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9584256"/>
        <c:axId val="99761536"/>
      </c:lineChart>
      <c:catAx>
        <c:axId val="9958425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99761536"/>
        <c:crosses val="autoZero"/>
        <c:auto val="1"/>
        <c:lblAlgn val="ctr"/>
        <c:lblOffset val="100"/>
        <c:noMultiLvlLbl val="0"/>
      </c:catAx>
      <c:valAx>
        <c:axId val="99761536"/>
        <c:scaling>
          <c:orientation val="minMax"/>
          <c:max val="1.4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/>
                </a:pPr>
                <a:r>
                  <a:rPr lang="en-US" sz="700"/>
                  <a:t>Relative Expression</a:t>
                </a:r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99584256"/>
        <c:crosses val="autoZero"/>
        <c:crossBetween val="between"/>
        <c:majorUnit val="0.2"/>
      </c:valAx>
    </c:plotArea>
    <c:legend>
      <c:legendPos val="t"/>
      <c:layout>
        <c:manualLayout>
          <c:xMode val="edge"/>
          <c:yMode val="edge"/>
          <c:x val="0.27651342298341147"/>
          <c:y val="2.0650264829546426E-2"/>
          <c:w val="0.49685422815573382"/>
          <c:h val="0.10041283902012248"/>
        </c:manualLayout>
      </c:layout>
      <c:overlay val="1"/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1"/>
          <c:tx>
            <c:v>SERINC3</c:v>
          </c:tx>
          <c:spPr>
            <a:solidFill>
              <a:schemeClr val="accent1">
                <a:lumMod val="60000"/>
                <a:lumOff val="4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For GraphPad FM55M1(Dupls)'!$K$38;'For GraphPad FM55M1(Dupls)'!$M$38;'For GraphPad FM55M1(Dupls)'!$O$38)</c:f>
                <c:numCache>
                  <c:formatCode>General</c:formatCode>
                  <c:ptCount val="3"/>
                  <c:pt idx="0">
                    <c:v>0.11564485120355172</c:v>
                  </c:pt>
                  <c:pt idx="1">
                    <c:v>0.23562971296909438</c:v>
                  </c:pt>
                  <c:pt idx="2">
                    <c:v>0.13301942999786856</c:v>
                  </c:pt>
                </c:numCache>
              </c:numRef>
            </c:plus>
            <c:minus>
              <c:numRef>
                <c:f>('For GraphPad FM55M1(Dupls)'!$K$38;'For GraphPad FM55M1(Dupls)'!$M$38;'For GraphPad FM55M1(Dupls)'!$O$38)</c:f>
                <c:numCache>
                  <c:formatCode>General</c:formatCode>
                  <c:ptCount val="3"/>
                  <c:pt idx="0">
                    <c:v>0.11564485120355172</c:v>
                  </c:pt>
                  <c:pt idx="1">
                    <c:v>0.23562971296909438</c:v>
                  </c:pt>
                  <c:pt idx="2">
                    <c:v>0.13301942999786856</c:v>
                  </c:pt>
                </c:numCache>
              </c:numRef>
            </c:minus>
          </c:errBars>
          <c:cat>
            <c:strRef>
              <c:f>'For GraphPad FM55M1(Dupls)'!$Q$1:$Q$3</c:f>
              <c:strCache>
                <c:ptCount val="3"/>
                <c:pt idx="0">
                  <c:v>24h</c:v>
                </c:pt>
                <c:pt idx="1">
                  <c:v>48h</c:v>
                </c:pt>
                <c:pt idx="2">
                  <c:v>72h</c:v>
                </c:pt>
              </c:strCache>
            </c:strRef>
          </c:cat>
          <c:val>
            <c:numRef>
              <c:f>('For GraphPad FM55M1(Dupls)'!$K$36;'For GraphPad FM55M1(Dupls)'!$M$36;'For GraphPad FM55M1(Dupls)'!$O$36)</c:f>
              <c:numCache>
                <c:formatCode>0.00</c:formatCode>
                <c:ptCount val="3"/>
                <c:pt idx="0">
                  <c:v>1.2832798024631538</c:v>
                </c:pt>
                <c:pt idx="1">
                  <c:v>1.3861532340295324</c:v>
                </c:pt>
                <c:pt idx="2">
                  <c:v>1.581172988148338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3587840"/>
        <c:axId val="103643008"/>
      </c:barChart>
      <c:lineChart>
        <c:grouping val="standard"/>
        <c:varyColors val="0"/>
        <c:ser>
          <c:idx val="1"/>
          <c:order val="0"/>
          <c:tx>
            <c:v>miR211</c:v>
          </c:tx>
          <c:spPr>
            <a:ln>
              <a:solidFill>
                <a:schemeClr val="tx1">
                  <a:lumMod val="65000"/>
                  <a:lumOff val="35000"/>
                </a:schemeClr>
              </a:solidFill>
            </a:ln>
          </c:spPr>
          <c:marker>
            <c:spPr>
              <a:solidFill>
                <a:schemeClr val="tx1">
                  <a:lumMod val="65000"/>
                  <a:lumOff val="35000"/>
                </a:schemeClr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For GraphPad FM55M1(Dupls)'!$K$12;'For GraphPad FM55M1(Dupls)'!$M$12;'For GraphPad FM55M1(Dupls)'!$O$12)</c:f>
                <c:numCache>
                  <c:formatCode>General</c:formatCode>
                  <c:ptCount val="3"/>
                  <c:pt idx="0">
                    <c:v>0.21239829593429507</c:v>
                  </c:pt>
                  <c:pt idx="1">
                    <c:v>0.19924439680856648</c:v>
                  </c:pt>
                  <c:pt idx="2">
                    <c:v>0.11827090535547406</c:v>
                  </c:pt>
                </c:numCache>
              </c:numRef>
            </c:plus>
            <c:minus>
              <c:numRef>
                <c:f>('For GraphPad FM55M1(Dupls)'!$K$12;'For GraphPad FM55M1(Dupls)'!$M$12;'For GraphPad FM55M1(Dupls)'!$O$12)</c:f>
                <c:numCache>
                  <c:formatCode>General</c:formatCode>
                  <c:ptCount val="3"/>
                  <c:pt idx="0">
                    <c:v>0.21239829593429507</c:v>
                  </c:pt>
                  <c:pt idx="1">
                    <c:v>0.19924439680856648</c:v>
                  </c:pt>
                  <c:pt idx="2">
                    <c:v>0.11827090535547406</c:v>
                  </c:pt>
                </c:numCache>
              </c:numRef>
            </c:minus>
          </c:errBars>
          <c:cat>
            <c:strRef>
              <c:f>'For GraphPad FM55M1(Dupls)'!$Q$1:$Q$3</c:f>
              <c:strCache>
                <c:ptCount val="3"/>
                <c:pt idx="0">
                  <c:v>24h</c:v>
                </c:pt>
                <c:pt idx="1">
                  <c:v>48h</c:v>
                </c:pt>
                <c:pt idx="2">
                  <c:v>72h</c:v>
                </c:pt>
              </c:strCache>
            </c:strRef>
          </c:cat>
          <c:val>
            <c:numRef>
              <c:f>('For GraphPad FM55M1(Dupls)'!$K$10;'For GraphPad FM55M1(Dupls)'!$M$10;'For GraphPad FM55M1(Dupls)'!$O$10)</c:f>
              <c:numCache>
                <c:formatCode>0.00</c:formatCode>
                <c:ptCount val="3"/>
                <c:pt idx="0">
                  <c:v>0.94597556453400722</c:v>
                </c:pt>
                <c:pt idx="1">
                  <c:v>0.69611823005674622</c:v>
                </c:pt>
                <c:pt idx="2">
                  <c:v>0.4691613698847438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3587840"/>
        <c:axId val="103643008"/>
      </c:lineChart>
      <c:catAx>
        <c:axId val="10358784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03643008"/>
        <c:crosses val="autoZero"/>
        <c:auto val="1"/>
        <c:lblAlgn val="ctr"/>
        <c:lblOffset val="100"/>
        <c:noMultiLvlLbl val="0"/>
      </c:catAx>
      <c:valAx>
        <c:axId val="103643008"/>
        <c:scaling>
          <c:orientation val="minMax"/>
          <c:max val="1.8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/>
                </a:pPr>
                <a:r>
                  <a:rPr lang="en-US" sz="700"/>
                  <a:t>Relative Expression</a:t>
                </a:r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03587840"/>
        <c:crosses val="autoZero"/>
        <c:crossBetween val="between"/>
        <c:majorUnit val="0.2"/>
      </c:valAx>
    </c:plotArea>
    <c:legend>
      <c:legendPos val="t"/>
      <c:layout>
        <c:manualLayout>
          <c:xMode val="edge"/>
          <c:yMode val="edge"/>
          <c:x val="0.28099557396413782"/>
          <c:y val="6.669862711350393E-3"/>
          <c:w val="0.49685422815573382"/>
          <c:h val="0.10041283902012248"/>
        </c:manualLayout>
      </c:layout>
      <c:overlay val="1"/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1"/>
          <c:tx>
            <c:v>RAB22A</c:v>
          </c:tx>
          <c:spPr>
            <a:solidFill>
              <a:schemeClr val="accent1">
                <a:lumMod val="60000"/>
                <a:lumOff val="4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For GraphPad FM55M1(Dupls)'!$K$25;'For GraphPad FM55M1(Dupls)'!$M$25;'For GraphPad FM55M1(Dupls)'!$O$25)</c:f>
                <c:numCache>
                  <c:formatCode>General</c:formatCode>
                  <c:ptCount val="3"/>
                  <c:pt idx="0">
                    <c:v>5.3918373496620563E-2</c:v>
                  </c:pt>
                  <c:pt idx="1">
                    <c:v>0.11758142267921549</c:v>
                  </c:pt>
                  <c:pt idx="2">
                    <c:v>0.1047083331156568</c:v>
                  </c:pt>
                </c:numCache>
              </c:numRef>
            </c:plus>
            <c:minus>
              <c:numRef>
                <c:f>('For GraphPad FM55M1(Dupls)'!$K$25;'For GraphPad FM55M1(Dupls)'!$M$25;'For GraphPad FM55M1(Dupls)'!$O$25)</c:f>
                <c:numCache>
                  <c:formatCode>General</c:formatCode>
                  <c:ptCount val="3"/>
                  <c:pt idx="0">
                    <c:v>5.3918373496620563E-2</c:v>
                  </c:pt>
                  <c:pt idx="1">
                    <c:v>0.11758142267921549</c:v>
                  </c:pt>
                  <c:pt idx="2">
                    <c:v>0.1047083331156568</c:v>
                  </c:pt>
                </c:numCache>
              </c:numRef>
            </c:minus>
          </c:errBars>
          <c:cat>
            <c:strRef>
              <c:f>'For GraphPad FM55M1(Dupls)'!$Q$1:$Q$3</c:f>
              <c:strCache>
                <c:ptCount val="3"/>
                <c:pt idx="0">
                  <c:v>24h</c:v>
                </c:pt>
                <c:pt idx="1">
                  <c:v>48h</c:v>
                </c:pt>
                <c:pt idx="2">
                  <c:v>72h</c:v>
                </c:pt>
              </c:strCache>
            </c:strRef>
          </c:cat>
          <c:val>
            <c:numRef>
              <c:f>('For GraphPad FM55M1(Dupls)'!$K$23;'For GraphPad FM55M1(Dupls)'!$M$23;'For GraphPad FM55M1(Dupls)'!$O$23)</c:f>
              <c:numCache>
                <c:formatCode>0.00</c:formatCode>
                <c:ptCount val="3"/>
                <c:pt idx="0">
                  <c:v>1.1352744001319337</c:v>
                </c:pt>
                <c:pt idx="1">
                  <c:v>1.3115914995734694</c:v>
                </c:pt>
                <c:pt idx="2">
                  <c:v>1.505622179591986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4543616"/>
        <c:axId val="123600896"/>
      </c:barChart>
      <c:lineChart>
        <c:grouping val="standard"/>
        <c:varyColors val="0"/>
        <c:ser>
          <c:idx val="1"/>
          <c:order val="0"/>
          <c:tx>
            <c:v>miR211</c:v>
          </c:tx>
          <c:spPr>
            <a:ln>
              <a:solidFill>
                <a:schemeClr val="tx1">
                  <a:lumMod val="65000"/>
                  <a:lumOff val="35000"/>
                </a:schemeClr>
              </a:solidFill>
            </a:ln>
          </c:spPr>
          <c:marker>
            <c:spPr>
              <a:solidFill>
                <a:schemeClr val="tx1">
                  <a:lumMod val="65000"/>
                  <a:lumOff val="35000"/>
                </a:schemeClr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For GraphPad FM55M1(Dupls)'!$K$12;'For GraphPad FM55M1(Dupls)'!$M$12;'For GraphPad FM55M1(Dupls)'!$O$12)</c:f>
                <c:numCache>
                  <c:formatCode>General</c:formatCode>
                  <c:ptCount val="3"/>
                  <c:pt idx="0">
                    <c:v>0.21239829593429507</c:v>
                  </c:pt>
                  <c:pt idx="1">
                    <c:v>0.19924439680856648</c:v>
                  </c:pt>
                  <c:pt idx="2">
                    <c:v>0.11827090535547406</c:v>
                  </c:pt>
                </c:numCache>
              </c:numRef>
            </c:plus>
            <c:minus>
              <c:numRef>
                <c:f>('For GraphPad FM55M1(Dupls)'!$K$12;'For GraphPad FM55M1(Dupls)'!$M$12;'For GraphPad FM55M1(Dupls)'!$O$12)</c:f>
                <c:numCache>
                  <c:formatCode>General</c:formatCode>
                  <c:ptCount val="3"/>
                  <c:pt idx="0">
                    <c:v>0.21239829593429507</c:v>
                  </c:pt>
                  <c:pt idx="1">
                    <c:v>0.19924439680856648</c:v>
                  </c:pt>
                  <c:pt idx="2">
                    <c:v>0.11827090535547406</c:v>
                  </c:pt>
                </c:numCache>
              </c:numRef>
            </c:minus>
          </c:errBars>
          <c:cat>
            <c:strRef>
              <c:f>'For GraphPad FM55M1(Dupls)'!$Q$1:$Q$3</c:f>
              <c:strCache>
                <c:ptCount val="3"/>
                <c:pt idx="0">
                  <c:v>24h</c:v>
                </c:pt>
                <c:pt idx="1">
                  <c:v>48h</c:v>
                </c:pt>
                <c:pt idx="2">
                  <c:v>72h</c:v>
                </c:pt>
              </c:strCache>
            </c:strRef>
          </c:cat>
          <c:val>
            <c:numRef>
              <c:f>('For GraphPad FM55M1(Dupls)'!$K$10;'For GraphPad FM55M1(Dupls)'!$M$10;'For GraphPad FM55M1(Dupls)'!$O$10)</c:f>
              <c:numCache>
                <c:formatCode>0.00</c:formatCode>
                <c:ptCount val="3"/>
                <c:pt idx="0">
                  <c:v>0.94597556453400722</c:v>
                </c:pt>
                <c:pt idx="1">
                  <c:v>0.69611823005674622</c:v>
                </c:pt>
                <c:pt idx="2">
                  <c:v>0.4691613698847438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14543616"/>
        <c:axId val="123600896"/>
      </c:lineChart>
      <c:catAx>
        <c:axId val="11454361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23600896"/>
        <c:crosses val="autoZero"/>
        <c:auto val="1"/>
        <c:lblAlgn val="ctr"/>
        <c:lblOffset val="100"/>
        <c:noMultiLvlLbl val="0"/>
      </c:catAx>
      <c:valAx>
        <c:axId val="123600896"/>
        <c:scaling>
          <c:orientation val="minMax"/>
          <c:max val="1.8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700"/>
                </a:pPr>
                <a:r>
                  <a:rPr lang="en-US" sz="700"/>
                  <a:t>Relative Expression</a:t>
                </a:r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700"/>
            </a:pPr>
            <a:endParaRPr lang="en-US"/>
          </a:p>
        </c:txPr>
        <c:crossAx val="114543616"/>
        <c:crosses val="autoZero"/>
        <c:crossBetween val="between"/>
        <c:majorUnit val="0.2"/>
      </c:valAx>
    </c:plotArea>
    <c:legend>
      <c:legendPos val="t"/>
      <c:layout>
        <c:manualLayout>
          <c:xMode val="edge"/>
          <c:yMode val="edge"/>
          <c:x val="0.27651342298341147"/>
          <c:y val="6.669862711350393E-3"/>
          <c:w val="0.49685422815573382"/>
          <c:h val="0.10041283902012248"/>
        </c:manualLayout>
      </c:layout>
      <c:overlay val="1"/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1071-0D57-43A0-BADF-DA56DD8EB5E9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0137A-8AF6-4008-B8F5-EC8885E80E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1071-0D57-43A0-BADF-DA56DD8EB5E9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0137A-8AF6-4008-B8F5-EC8885E80E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1071-0D57-43A0-BADF-DA56DD8EB5E9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0137A-8AF6-4008-B8F5-EC8885E80E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1071-0D57-43A0-BADF-DA56DD8EB5E9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0137A-8AF6-4008-B8F5-EC8885E80E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1071-0D57-43A0-BADF-DA56DD8EB5E9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0137A-8AF6-4008-B8F5-EC8885E80E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1071-0D57-43A0-BADF-DA56DD8EB5E9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0137A-8AF6-4008-B8F5-EC8885E80E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1071-0D57-43A0-BADF-DA56DD8EB5E9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0137A-8AF6-4008-B8F5-EC8885E80E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1071-0D57-43A0-BADF-DA56DD8EB5E9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0137A-8AF6-4008-B8F5-EC8885E80E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1071-0D57-43A0-BADF-DA56DD8EB5E9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0137A-8AF6-4008-B8F5-EC8885E80E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1071-0D57-43A0-BADF-DA56DD8EB5E9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0137A-8AF6-4008-B8F5-EC8885E80E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0E1071-0D57-43A0-BADF-DA56DD8EB5E9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0137A-8AF6-4008-B8F5-EC8885E80E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0E1071-0D57-43A0-BADF-DA56DD8EB5E9}" type="datetimeFigureOut">
              <a:rPr lang="en-US" smtClean="0"/>
              <a:pPr/>
              <a:t>3/12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40137A-8AF6-4008-B8F5-EC8885E80EC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oup 32"/>
          <p:cNvGrpSpPr/>
          <p:nvPr/>
        </p:nvGrpSpPr>
        <p:grpSpPr>
          <a:xfrm>
            <a:off x="476672" y="827584"/>
            <a:ext cx="5690649" cy="6408712"/>
            <a:chOff x="476672" y="827584"/>
            <a:chExt cx="5690649" cy="6408712"/>
          </a:xfrm>
        </p:grpSpPr>
        <p:grpSp>
          <p:nvGrpSpPr>
            <p:cNvPr id="44" name="Group 43"/>
            <p:cNvGrpSpPr/>
            <p:nvPr/>
          </p:nvGrpSpPr>
          <p:grpSpPr>
            <a:xfrm>
              <a:off x="476672" y="5419467"/>
              <a:ext cx="2833461" cy="1816829"/>
              <a:chOff x="476672" y="4806051"/>
              <a:chExt cx="2833461" cy="1816829"/>
            </a:xfrm>
          </p:grpSpPr>
          <p:graphicFrame>
            <p:nvGraphicFramePr>
              <p:cNvPr id="10" name="Chart 9"/>
              <p:cNvGraphicFramePr/>
              <p:nvPr/>
            </p:nvGraphicFramePr>
            <p:xfrm>
              <a:off x="476672" y="4806051"/>
              <a:ext cx="2833461" cy="181682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13" name="TextBox 12"/>
              <p:cNvSpPr txBox="1"/>
              <p:nvPr/>
            </p:nvSpPr>
            <p:spPr>
              <a:xfrm>
                <a:off x="1844824" y="5292080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/>
                  <a:t>***</a:t>
                </a:r>
                <a:endParaRPr lang="en-US" sz="1000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2636912" y="5333891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***</a:t>
                </a:r>
                <a:endParaRPr lang="en-US" sz="1000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1196752" y="5045859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**</a:t>
                </a:r>
                <a:endParaRPr lang="en-US" sz="1000" dirty="0"/>
              </a:p>
            </p:txBody>
          </p:sp>
        </p:grpSp>
        <p:grpSp>
          <p:nvGrpSpPr>
            <p:cNvPr id="45" name="Group 44"/>
            <p:cNvGrpSpPr/>
            <p:nvPr/>
          </p:nvGrpSpPr>
          <p:grpSpPr>
            <a:xfrm>
              <a:off x="3333860" y="5419467"/>
              <a:ext cx="2833461" cy="1816829"/>
              <a:chOff x="3333860" y="4806051"/>
              <a:chExt cx="2833461" cy="1816829"/>
            </a:xfrm>
          </p:grpSpPr>
          <p:graphicFrame>
            <p:nvGraphicFramePr>
              <p:cNvPr id="9" name="Chart 8"/>
              <p:cNvGraphicFramePr/>
              <p:nvPr/>
            </p:nvGraphicFramePr>
            <p:xfrm>
              <a:off x="3333860" y="4806051"/>
              <a:ext cx="2833461" cy="181682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7" name="TextBox 16"/>
              <p:cNvSpPr txBox="1"/>
              <p:nvPr/>
            </p:nvSpPr>
            <p:spPr>
              <a:xfrm>
                <a:off x="4725144" y="5148064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/>
                  <a:t>ns</a:t>
                </a:r>
                <a:endParaRPr lang="en-US" sz="1000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5517232" y="5333891"/>
                <a:ext cx="28803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/>
                  <a:t>*</a:t>
                </a:r>
                <a:endParaRPr lang="en-US" sz="1000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4005064" y="4973851"/>
                <a:ext cx="36004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/>
                  <a:t>ns</a:t>
                </a:r>
                <a:endParaRPr lang="en-US" sz="1000" dirty="0"/>
              </a:p>
            </p:txBody>
          </p:sp>
        </p:grpSp>
        <p:grpSp>
          <p:nvGrpSpPr>
            <p:cNvPr id="43" name="Group 42"/>
            <p:cNvGrpSpPr/>
            <p:nvPr/>
          </p:nvGrpSpPr>
          <p:grpSpPr>
            <a:xfrm>
              <a:off x="1921127" y="3280961"/>
              <a:ext cx="2833461" cy="1816829"/>
              <a:chOff x="1921127" y="2955577"/>
              <a:chExt cx="2833461" cy="1816829"/>
            </a:xfrm>
          </p:grpSpPr>
          <p:graphicFrame>
            <p:nvGraphicFramePr>
              <p:cNvPr id="8" name="Chart 7"/>
              <p:cNvGraphicFramePr/>
              <p:nvPr/>
            </p:nvGraphicFramePr>
            <p:xfrm>
              <a:off x="1921127" y="2955577"/>
              <a:ext cx="2833461" cy="181682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5" name="TextBox 14"/>
              <p:cNvSpPr txBox="1"/>
              <p:nvPr/>
            </p:nvSpPr>
            <p:spPr>
              <a:xfrm>
                <a:off x="2636912" y="3173651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**</a:t>
                </a:r>
                <a:endParaRPr lang="en-US" sz="1000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4077072" y="3419872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ns</a:t>
                </a:r>
                <a:endParaRPr lang="en-US" sz="1000" dirty="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3356992" y="3203848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ns</a:t>
                </a:r>
                <a:endParaRPr lang="en-US" sz="1000" dirty="0"/>
              </a:p>
            </p:txBody>
          </p:sp>
        </p:grpSp>
        <p:grpSp>
          <p:nvGrpSpPr>
            <p:cNvPr id="42" name="Group 41"/>
            <p:cNvGrpSpPr/>
            <p:nvPr/>
          </p:nvGrpSpPr>
          <p:grpSpPr>
            <a:xfrm>
              <a:off x="3333860" y="1115616"/>
              <a:ext cx="2833461" cy="1816829"/>
              <a:chOff x="3333860" y="1115616"/>
              <a:chExt cx="2833461" cy="1816829"/>
            </a:xfrm>
          </p:grpSpPr>
          <p:graphicFrame>
            <p:nvGraphicFramePr>
              <p:cNvPr id="7" name="Chart 6"/>
              <p:cNvGraphicFramePr/>
              <p:nvPr/>
            </p:nvGraphicFramePr>
            <p:xfrm>
              <a:off x="3333860" y="1115616"/>
              <a:ext cx="2833461" cy="181682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12" name="TextBox 11"/>
              <p:cNvSpPr txBox="1"/>
              <p:nvPr/>
            </p:nvSpPr>
            <p:spPr>
              <a:xfrm>
                <a:off x="5445224" y="1187624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/>
                  <a:t>***</a:t>
                </a:r>
                <a:endParaRPr lang="en-US" sz="1000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4005064" y="1403648"/>
                <a:ext cx="36004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/>
                  <a:t>**</a:t>
                </a:r>
                <a:endParaRPr lang="en-US" sz="1000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4797152" y="1187624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ns</a:t>
                </a:r>
                <a:endParaRPr lang="en-US" sz="1000" dirty="0"/>
              </a:p>
            </p:txBody>
          </p:sp>
        </p:grpSp>
        <p:grpSp>
          <p:nvGrpSpPr>
            <p:cNvPr id="41" name="Group 40"/>
            <p:cNvGrpSpPr/>
            <p:nvPr/>
          </p:nvGrpSpPr>
          <p:grpSpPr>
            <a:xfrm>
              <a:off x="476672" y="1115616"/>
              <a:ext cx="2833461" cy="1816829"/>
              <a:chOff x="476672" y="1115616"/>
              <a:chExt cx="2833461" cy="1816829"/>
            </a:xfrm>
          </p:grpSpPr>
          <p:graphicFrame>
            <p:nvGraphicFramePr>
              <p:cNvPr id="6" name="Chart 5"/>
              <p:cNvGraphicFramePr/>
              <p:nvPr/>
            </p:nvGraphicFramePr>
            <p:xfrm>
              <a:off x="476672" y="1115616"/>
              <a:ext cx="2833461" cy="181682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11" name="TextBox 10"/>
              <p:cNvSpPr txBox="1"/>
              <p:nvPr/>
            </p:nvSpPr>
            <p:spPr>
              <a:xfrm>
                <a:off x="2636912" y="1259632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***</a:t>
                </a:r>
                <a:endParaRPr lang="en-US" sz="1000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1916832" y="1403648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**</a:t>
                </a:r>
                <a:endParaRPr lang="en-US" sz="1000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1196752" y="1517467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/>
                  <a:t>ns</a:t>
                </a:r>
                <a:endParaRPr lang="en-US" sz="1000" dirty="0"/>
              </a:p>
            </p:txBody>
          </p:sp>
        </p:grpSp>
        <p:sp>
          <p:nvSpPr>
            <p:cNvPr id="28" name="TextBox 27"/>
            <p:cNvSpPr txBox="1"/>
            <p:nvPr/>
          </p:nvSpPr>
          <p:spPr>
            <a:xfrm>
              <a:off x="1628800" y="827584"/>
              <a:ext cx="7008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/>
                <a:t>RAB22A</a:t>
              </a:r>
              <a:endParaRPr lang="en-US" sz="1200" b="1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581128" y="827584"/>
              <a:ext cx="7216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/>
                <a:t>SERINC3</a:t>
              </a:r>
              <a:endParaRPr lang="en-US" sz="1200" b="1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068960" y="3059832"/>
              <a:ext cx="5886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/>
                <a:t>AP1S2</a:t>
              </a:r>
              <a:endParaRPr lang="en-US" sz="1200" b="1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844824" y="5148064"/>
              <a:ext cx="5661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/>
                <a:t>M6PR</a:t>
              </a:r>
              <a:endParaRPr lang="en-US" sz="1200" b="1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653136" y="5148064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smtClean="0"/>
                <a:t>SSRP1</a:t>
              </a:r>
              <a:endParaRPr lang="en-US" sz="1200" b="1" dirty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30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us</dc:creator>
  <cp:lastModifiedBy>Christiane MARGUE</cp:lastModifiedBy>
  <cp:revision>19</cp:revision>
  <dcterms:created xsi:type="dcterms:W3CDTF">2012-06-28T05:04:15Z</dcterms:created>
  <dcterms:modified xsi:type="dcterms:W3CDTF">2013-03-12T09:18:05Z</dcterms:modified>
</cp:coreProperties>
</file>